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6D191E4-F19F-448B-91E6-98E3E008703B}" v="1" dt="2022-04-21T00:22:39.82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7" autoAdjust="0"/>
    <p:restoredTop sz="94660"/>
  </p:normalViewPr>
  <p:slideViewPr>
    <p:cSldViewPr snapToGrid="0">
      <p:cViewPr varScale="1">
        <p:scale>
          <a:sx n="154" d="100"/>
          <a:sy n="154" d="100"/>
        </p:scale>
        <p:origin x="12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&#53685;&#54633;%20&#47928;&#49436;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711133220363436"/>
          <c:y val="2.5141825451302065E-2"/>
          <c:w val="0.82512639380848185"/>
          <c:h val="0.73601217102086502"/>
        </c:manualLayout>
      </c:layout>
      <c:lineChart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PCR positive rate (%)</c:v>
                </c:pt>
              </c:strCache>
            </c:strRef>
          </c:tx>
          <c:spPr>
            <a:ln w="2222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Sheet1!$A$2:$A$16</c:f>
              <c:numCache>
                <c:formatCode>mmm\-yy</c:formatCode>
                <c:ptCount val="15"/>
                <c:pt idx="0">
                  <c:v>44197</c:v>
                </c:pt>
                <c:pt idx="1">
                  <c:v>44228</c:v>
                </c:pt>
                <c:pt idx="2">
                  <c:v>44256</c:v>
                </c:pt>
                <c:pt idx="3">
                  <c:v>44287</c:v>
                </c:pt>
                <c:pt idx="4">
                  <c:v>44317</c:v>
                </c:pt>
                <c:pt idx="5">
                  <c:v>44348</c:v>
                </c:pt>
                <c:pt idx="6">
                  <c:v>44378</c:v>
                </c:pt>
                <c:pt idx="7">
                  <c:v>44409</c:v>
                </c:pt>
                <c:pt idx="8">
                  <c:v>44440</c:v>
                </c:pt>
                <c:pt idx="9">
                  <c:v>44470</c:v>
                </c:pt>
                <c:pt idx="10">
                  <c:v>44501</c:v>
                </c:pt>
                <c:pt idx="11">
                  <c:v>44531</c:v>
                </c:pt>
                <c:pt idx="12">
                  <c:v>44562</c:v>
                </c:pt>
                <c:pt idx="13">
                  <c:v>44593</c:v>
                </c:pt>
                <c:pt idx="14">
                  <c:v>44621</c:v>
                </c:pt>
              </c:numCache>
            </c:numRef>
          </c:cat>
          <c:val>
            <c:numRef>
              <c:f>Sheet1!$B$2:$B$16</c:f>
              <c:numCache>
                <c:formatCode>0%</c:formatCode>
                <c:ptCount val="15"/>
                <c:pt idx="0" formatCode="0.0%">
                  <c:v>1.8867924528301889E-3</c:v>
                </c:pt>
                <c:pt idx="1">
                  <c:v>0</c:v>
                </c:pt>
                <c:pt idx="2" formatCode="0.0%">
                  <c:v>1.4005602240896359E-3</c:v>
                </c:pt>
                <c:pt idx="3" formatCode="0.0%">
                  <c:v>6.4724919093851144E-3</c:v>
                </c:pt>
                <c:pt idx="4" formatCode="0.0%">
                  <c:v>9.6711798839458421E-3</c:v>
                </c:pt>
                <c:pt idx="5" formatCode="0.0%">
                  <c:v>5.0150451354062184E-3</c:v>
                </c:pt>
                <c:pt idx="6" formatCode="0.0%">
                  <c:v>4.8262548262548256E-2</c:v>
                </c:pt>
                <c:pt idx="7" formatCode="0.0%">
                  <c:v>4.0034812880765894E-2</c:v>
                </c:pt>
                <c:pt idx="8" formatCode="0.0%">
                  <c:v>4.7480620155038761E-2</c:v>
                </c:pt>
                <c:pt idx="9" formatCode="0.0%">
                  <c:v>1.4150943396226417E-2</c:v>
                </c:pt>
                <c:pt idx="10" formatCode="0.0%">
                  <c:v>1.6848364717542121E-2</c:v>
                </c:pt>
                <c:pt idx="11" formatCode="0.0%">
                  <c:v>2.9970029970029972E-2</c:v>
                </c:pt>
                <c:pt idx="12" formatCode="0.0%">
                  <c:v>3.1536113936927769E-2</c:v>
                </c:pt>
                <c:pt idx="13" formatCode="0.0%">
                  <c:v>0.12109744560075686</c:v>
                </c:pt>
                <c:pt idx="14" formatCode="0.0%">
                  <c:v>0.2483900643974241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EA2-4A39-9613-B25E973223E1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Specificity</c:v>
                </c:pt>
              </c:strCache>
            </c:strRef>
          </c:tx>
          <c:spPr>
            <a:ln w="22225" cap="rnd">
              <a:solidFill>
                <a:srgbClr val="C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C00000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numRef>
              <c:f>Sheet1!$A$2:$A$16</c:f>
              <c:numCache>
                <c:formatCode>mmm\-yy</c:formatCode>
                <c:ptCount val="15"/>
                <c:pt idx="0">
                  <c:v>44197</c:v>
                </c:pt>
                <c:pt idx="1">
                  <c:v>44228</c:v>
                </c:pt>
                <c:pt idx="2">
                  <c:v>44256</c:v>
                </c:pt>
                <c:pt idx="3">
                  <c:v>44287</c:v>
                </c:pt>
                <c:pt idx="4">
                  <c:v>44317</c:v>
                </c:pt>
                <c:pt idx="5">
                  <c:v>44348</c:v>
                </c:pt>
                <c:pt idx="6">
                  <c:v>44378</c:v>
                </c:pt>
                <c:pt idx="7">
                  <c:v>44409</c:v>
                </c:pt>
                <c:pt idx="8">
                  <c:v>44440</c:v>
                </c:pt>
                <c:pt idx="9">
                  <c:v>44470</c:v>
                </c:pt>
                <c:pt idx="10">
                  <c:v>44501</c:v>
                </c:pt>
                <c:pt idx="11">
                  <c:v>44531</c:v>
                </c:pt>
                <c:pt idx="12">
                  <c:v>44562</c:v>
                </c:pt>
                <c:pt idx="13">
                  <c:v>44593</c:v>
                </c:pt>
                <c:pt idx="14">
                  <c:v>44621</c:v>
                </c:pt>
              </c:numCache>
            </c:numRef>
          </c:cat>
          <c:val>
            <c:numRef>
              <c:f>Sheet1!$C$2:$C$16</c:f>
              <c:numCache>
                <c:formatCode>0.0%</c:formatCode>
                <c:ptCount val="15"/>
                <c:pt idx="0">
                  <c:v>0.99054820415879019</c:v>
                </c:pt>
                <c:pt idx="1">
                  <c:v>0.98269896193771622</c:v>
                </c:pt>
                <c:pt idx="2">
                  <c:v>0.99158485273492281</c:v>
                </c:pt>
                <c:pt idx="3">
                  <c:v>0.98697068403908794</c:v>
                </c:pt>
                <c:pt idx="4">
                  <c:v>0.9931640625</c:v>
                </c:pt>
                <c:pt idx="5">
                  <c:v>0.99697275479313829</c:v>
                </c:pt>
                <c:pt idx="6">
                  <c:v>1</c:v>
                </c:pt>
                <c:pt idx="7">
                  <c:v>0.99909255898366611</c:v>
                </c:pt>
                <c:pt idx="8">
                  <c:v>0.99592252803261982</c:v>
                </c:pt>
                <c:pt idx="9">
                  <c:v>0.99712092130518237</c:v>
                </c:pt>
                <c:pt idx="10">
                  <c:v>0.99091826437941477</c:v>
                </c:pt>
                <c:pt idx="11">
                  <c:v>0.99793814432989691</c:v>
                </c:pt>
                <c:pt idx="12">
                  <c:v>0.98206751054852326</c:v>
                </c:pt>
                <c:pt idx="13">
                  <c:v>0.98150163220892273</c:v>
                </c:pt>
                <c:pt idx="14">
                  <c:v>0.969658659924146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0EA2-4A39-9613-B25E973223E1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Sensitivity</c:v>
                </c:pt>
              </c:strCache>
            </c:strRef>
          </c:tx>
          <c:spPr>
            <a:ln w="2222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numRef>
              <c:f>Sheet1!$A$2:$A$16</c:f>
              <c:numCache>
                <c:formatCode>mmm\-yy</c:formatCode>
                <c:ptCount val="15"/>
                <c:pt idx="0">
                  <c:v>44197</c:v>
                </c:pt>
                <c:pt idx="1">
                  <c:v>44228</c:v>
                </c:pt>
                <c:pt idx="2">
                  <c:v>44256</c:v>
                </c:pt>
                <c:pt idx="3">
                  <c:v>44287</c:v>
                </c:pt>
                <c:pt idx="4">
                  <c:v>44317</c:v>
                </c:pt>
                <c:pt idx="5">
                  <c:v>44348</c:v>
                </c:pt>
                <c:pt idx="6">
                  <c:v>44378</c:v>
                </c:pt>
                <c:pt idx="7">
                  <c:v>44409</c:v>
                </c:pt>
                <c:pt idx="8">
                  <c:v>44440</c:v>
                </c:pt>
                <c:pt idx="9">
                  <c:v>44470</c:v>
                </c:pt>
                <c:pt idx="10">
                  <c:v>44501</c:v>
                </c:pt>
                <c:pt idx="11">
                  <c:v>44531</c:v>
                </c:pt>
                <c:pt idx="12">
                  <c:v>44562</c:v>
                </c:pt>
                <c:pt idx="13">
                  <c:v>44593</c:v>
                </c:pt>
                <c:pt idx="14">
                  <c:v>44621</c:v>
                </c:pt>
              </c:numCache>
            </c:numRef>
          </c:cat>
          <c:val>
            <c:numRef>
              <c:f>Sheet1!$D$2:$D$16</c:f>
              <c:numCache>
                <c:formatCode>General</c:formatCode>
                <c:ptCount val="15"/>
                <c:pt idx="2" formatCode="0.0%">
                  <c:v>1</c:v>
                </c:pt>
                <c:pt idx="3" formatCode="0.0%">
                  <c:v>1</c:v>
                </c:pt>
                <c:pt idx="4" formatCode="0.0%">
                  <c:v>0.7</c:v>
                </c:pt>
                <c:pt idx="5" formatCode="0.0%">
                  <c:v>0.6</c:v>
                </c:pt>
                <c:pt idx="6" formatCode="0.0%">
                  <c:v>0.6</c:v>
                </c:pt>
                <c:pt idx="7" formatCode="0.0%">
                  <c:v>0.73913043478260865</c:v>
                </c:pt>
                <c:pt idx="8" formatCode="0.0%">
                  <c:v>0.69387755102040816</c:v>
                </c:pt>
                <c:pt idx="9" formatCode="0.0%">
                  <c:v>0.53333333333333333</c:v>
                </c:pt>
                <c:pt idx="10" formatCode="0.0%">
                  <c:v>0.70588235294117652</c:v>
                </c:pt>
                <c:pt idx="11" formatCode="0.0%">
                  <c:v>0.53333333333333333</c:v>
                </c:pt>
                <c:pt idx="12" formatCode="0.0%">
                  <c:v>0.58064516129032262</c:v>
                </c:pt>
                <c:pt idx="13" formatCode="0.0%">
                  <c:v>0.6171875</c:v>
                </c:pt>
                <c:pt idx="14" formatCode="0.0%">
                  <c:v>0.4888888888888888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0EA2-4A39-9613-B25E973223E1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Negative predictive value</c:v>
                </c:pt>
              </c:strCache>
            </c:strRef>
          </c:tx>
          <c:spPr>
            <a:ln w="2222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numRef>
              <c:f>Sheet1!$A$2:$A$16</c:f>
              <c:numCache>
                <c:formatCode>mmm\-yy</c:formatCode>
                <c:ptCount val="15"/>
                <c:pt idx="0">
                  <c:v>44197</c:v>
                </c:pt>
                <c:pt idx="1">
                  <c:v>44228</c:v>
                </c:pt>
                <c:pt idx="2">
                  <c:v>44256</c:v>
                </c:pt>
                <c:pt idx="3">
                  <c:v>44287</c:v>
                </c:pt>
                <c:pt idx="4">
                  <c:v>44317</c:v>
                </c:pt>
                <c:pt idx="5">
                  <c:v>44348</c:v>
                </c:pt>
                <c:pt idx="6">
                  <c:v>44378</c:v>
                </c:pt>
                <c:pt idx="7">
                  <c:v>44409</c:v>
                </c:pt>
                <c:pt idx="8">
                  <c:v>44440</c:v>
                </c:pt>
                <c:pt idx="9">
                  <c:v>44470</c:v>
                </c:pt>
                <c:pt idx="10">
                  <c:v>44501</c:v>
                </c:pt>
                <c:pt idx="11">
                  <c:v>44531</c:v>
                </c:pt>
                <c:pt idx="12">
                  <c:v>44562</c:v>
                </c:pt>
                <c:pt idx="13">
                  <c:v>44593</c:v>
                </c:pt>
                <c:pt idx="14">
                  <c:v>44621</c:v>
                </c:pt>
              </c:numCache>
            </c:numRef>
          </c:cat>
          <c:val>
            <c:numRef>
              <c:f>Sheet1!$E$2:$E$16</c:f>
              <c:numCache>
                <c:formatCode>0.0%</c:formatCode>
                <c:ptCount val="15"/>
                <c:pt idx="0">
                  <c:v>0.99809523809523815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0.99705882352941178</c:v>
                </c:pt>
                <c:pt idx="5">
                  <c:v>0.99697275479313829</c:v>
                </c:pt>
                <c:pt idx="6">
                  <c:v>0.97813121272365811</c:v>
                </c:pt>
                <c:pt idx="7">
                  <c:v>0.98833034111310591</c:v>
                </c:pt>
                <c:pt idx="8">
                  <c:v>0.98289738430583506</c:v>
                </c:pt>
                <c:pt idx="9">
                  <c:v>0.99046711153479505</c:v>
                </c:pt>
                <c:pt idx="10">
                  <c:v>0.99392712550607287</c:v>
                </c:pt>
                <c:pt idx="11">
                  <c:v>0.98474059003051884</c:v>
                </c:pt>
                <c:pt idx="12">
                  <c:v>0.98206751054852326</c:v>
                </c:pt>
                <c:pt idx="13">
                  <c:v>0.93860561914672214</c:v>
                </c:pt>
                <c:pt idx="14">
                  <c:v>0.8238453276047260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0EA2-4A39-9613-B25E973223E1}"/>
            </c:ext>
          </c:extLst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Positive predictive value</c:v>
                </c:pt>
              </c:strCache>
            </c:strRef>
          </c:tx>
          <c:spPr>
            <a:ln w="22225" cap="rnd">
              <a:solidFill>
                <a:schemeClr val="tx1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numRef>
              <c:f>Sheet1!$A$2:$A$16</c:f>
              <c:numCache>
                <c:formatCode>mmm\-yy</c:formatCode>
                <c:ptCount val="15"/>
                <c:pt idx="0">
                  <c:v>44197</c:v>
                </c:pt>
                <c:pt idx="1">
                  <c:v>44228</c:v>
                </c:pt>
                <c:pt idx="2">
                  <c:v>44256</c:v>
                </c:pt>
                <c:pt idx="3">
                  <c:v>44287</c:v>
                </c:pt>
                <c:pt idx="4">
                  <c:v>44317</c:v>
                </c:pt>
                <c:pt idx="5">
                  <c:v>44348</c:v>
                </c:pt>
                <c:pt idx="6">
                  <c:v>44378</c:v>
                </c:pt>
                <c:pt idx="7">
                  <c:v>44409</c:v>
                </c:pt>
                <c:pt idx="8">
                  <c:v>44440</c:v>
                </c:pt>
                <c:pt idx="9">
                  <c:v>44470</c:v>
                </c:pt>
                <c:pt idx="10">
                  <c:v>44501</c:v>
                </c:pt>
                <c:pt idx="11">
                  <c:v>44531</c:v>
                </c:pt>
                <c:pt idx="12">
                  <c:v>44562</c:v>
                </c:pt>
                <c:pt idx="13">
                  <c:v>44593</c:v>
                </c:pt>
                <c:pt idx="14">
                  <c:v>44621</c:v>
                </c:pt>
              </c:numCache>
            </c:numRef>
          </c:cat>
          <c:val>
            <c:numRef>
              <c:f>Sheet1!$F$2:$F$16</c:f>
              <c:numCache>
                <c:formatCode>0.0%</c:formatCode>
                <c:ptCount val="15"/>
                <c:pt idx="0">
                  <c:v>0</c:v>
                </c:pt>
                <c:pt idx="1">
                  <c:v>0</c:v>
                </c:pt>
                <c:pt idx="2">
                  <c:v>0.14285714285714285</c:v>
                </c:pt>
                <c:pt idx="3">
                  <c:v>0.33333333333333331</c:v>
                </c:pt>
                <c:pt idx="4">
                  <c:v>0.5</c:v>
                </c:pt>
                <c:pt idx="5">
                  <c:v>0.5</c:v>
                </c:pt>
                <c:pt idx="6">
                  <c:v>1</c:v>
                </c:pt>
                <c:pt idx="7">
                  <c:v>0.97142857142857142</c:v>
                </c:pt>
                <c:pt idx="8">
                  <c:v>0.89473684210526316</c:v>
                </c:pt>
                <c:pt idx="9">
                  <c:v>0.72727272727272729</c:v>
                </c:pt>
                <c:pt idx="10">
                  <c:v>0.5714285714285714</c:v>
                </c:pt>
                <c:pt idx="11">
                  <c:v>0.88888888888888884</c:v>
                </c:pt>
                <c:pt idx="12">
                  <c:v>0.51428571428571423</c:v>
                </c:pt>
                <c:pt idx="13">
                  <c:v>0.82291666666666663</c:v>
                </c:pt>
                <c:pt idx="14">
                  <c:v>0.8461538461538461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0EA2-4A39-9613-B25E973223E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82557712"/>
        <c:axId val="2082567280"/>
      </c:lineChart>
      <c:dateAx>
        <c:axId val="2082557712"/>
        <c:scaling>
          <c:orientation val="minMax"/>
        </c:scaling>
        <c:delete val="0"/>
        <c:axPos val="b"/>
        <c:numFmt formatCode="mmm\-yy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2082567280"/>
        <c:crosses val="autoZero"/>
        <c:auto val="1"/>
        <c:lblOffset val="100"/>
        <c:baseTimeUnit val="months"/>
      </c:dateAx>
      <c:valAx>
        <c:axId val="2082567280"/>
        <c:scaling>
          <c:orientation val="minMax"/>
          <c:max val="1.1000000000000001"/>
          <c:min val="0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2082557712"/>
        <c:crosses val="autoZero"/>
        <c:crossBetween val="between"/>
      </c:valAx>
      <c:dTable>
        <c:showHorzBorder val="1"/>
        <c:showVertBorder val="1"/>
        <c:showOutline val="1"/>
        <c:showKeys val="1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vert="horz" wrap="square" anchor="ctr" anchorCtr="1"/>
          <a:lstStyle/>
          <a:p>
            <a:pPr rtl="0"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</c:dTable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8FFFB08-F38B-477A-B73F-23BD4C9BA51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41E73043-90CF-44AF-A0F1-D3BB3C813E4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9C83B1C-C845-4093-832E-85EA78B32F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2D03E-A0D0-407D-AEB6-117DCB17B8CB}" type="datetimeFigureOut">
              <a:rPr lang="ko-KR" altLang="en-US" smtClean="0"/>
              <a:t>2022-04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D85B874-887D-4C41-9BBB-9F2940DA52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7ED3996-253C-4794-8866-7E0F36F741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CCC09-8725-44F9-B521-A4E7DB0032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09109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CE9E95D-9C25-44F7-AA01-05A0B1B1BB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74FAD6A5-C829-47C8-B6BA-D53DF3E9C3D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1820E20-1A54-46BE-93BC-ECB2D02EA4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2D03E-A0D0-407D-AEB6-117DCB17B8CB}" type="datetimeFigureOut">
              <a:rPr lang="ko-KR" altLang="en-US" smtClean="0"/>
              <a:t>2022-04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B82F6FC-0767-4A6D-9A76-21FF445A52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2784EA9-555A-4CC7-A95F-313C10B2A1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CCC09-8725-44F9-B521-A4E7DB0032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87668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58657AEF-C689-4E41-ACE0-3A953BB57DD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AE7CC956-1EA9-47E6-B0E3-1038095F2E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CBC555C-0644-4047-83EE-3B1ED7541E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2D03E-A0D0-407D-AEB6-117DCB17B8CB}" type="datetimeFigureOut">
              <a:rPr lang="ko-KR" altLang="en-US" smtClean="0"/>
              <a:t>2022-04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E94B8C7-1DF8-4513-BA93-AF5001FE84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2204FE3-213E-4969-AEB0-866C51D120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CCC09-8725-44F9-B521-A4E7DB0032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49718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A6E6FFA-8D16-42DB-B3B1-B9F47B1F0B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F3F8841A-5D8C-45A9-A605-9064C832D4C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615EA66-8F0E-499D-85FD-FB27739EF0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2D03E-A0D0-407D-AEB6-117DCB17B8CB}" type="datetimeFigureOut">
              <a:rPr lang="ko-KR" altLang="en-US" smtClean="0"/>
              <a:t>2022-04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92F58BF-9FF0-4724-BCEF-ECF5E58331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FDE1E01-2339-49DF-B0BF-637FE39A7F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CCC09-8725-44F9-B521-A4E7DB0032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28293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164E6E4-423E-493B-A2D8-CE68B9827D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6429D73E-19F6-4CD6-A5BE-70C167C695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D855B1E-7180-4D3E-8CA6-BB5F37F023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2D03E-A0D0-407D-AEB6-117DCB17B8CB}" type="datetimeFigureOut">
              <a:rPr lang="ko-KR" altLang="en-US" smtClean="0"/>
              <a:t>2022-04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3DCDE00-98DD-47E7-9A39-E3E1DAB801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C9BB2C0-0BBD-4AC7-92B7-2BD2A04130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CCC09-8725-44F9-B521-A4E7DB0032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636696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0411747-EB3C-49BF-A506-0439793B32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6FA17F1A-E283-439E-BDD6-6567C98866E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E4BE2727-4790-4B3B-82DA-8D3067A272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1A51C84D-B2FD-4C8C-B0CF-29203CC733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2D03E-A0D0-407D-AEB6-117DCB17B8CB}" type="datetimeFigureOut">
              <a:rPr lang="ko-KR" altLang="en-US" smtClean="0"/>
              <a:t>2022-04-2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FC91FD2E-8251-4D98-A6E6-D9E12F1392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7E609014-67CF-4AB8-B553-AF2448B357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CCC09-8725-44F9-B521-A4E7DB0032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84646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969C78C-D02A-4570-BD9A-0698962FF4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5EB9D1C0-540E-496E-874D-93254056BF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25E52B17-928C-4E40-8A77-97CFDF3730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42DBDEE8-765A-43E0-AB1A-96B672D8AC6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A3FEC508-866A-4CFA-B9C1-3B795E66581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612B6A98-0D87-41D3-9463-75A013BF92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2D03E-A0D0-407D-AEB6-117DCB17B8CB}" type="datetimeFigureOut">
              <a:rPr lang="ko-KR" altLang="en-US" smtClean="0"/>
              <a:t>2022-04-21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4810BD89-3B27-4B2B-B382-047369630E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7008A0D4-CA76-4ADD-A8E3-954A0AD847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CCC09-8725-44F9-B521-A4E7DB0032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830941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F1423F1-2B12-4FE9-9AB7-26A4528B29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70F3AA8B-2A0A-47B5-B5A8-268B2106A5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2D03E-A0D0-407D-AEB6-117DCB17B8CB}" type="datetimeFigureOut">
              <a:rPr lang="ko-KR" altLang="en-US" smtClean="0"/>
              <a:t>2022-04-21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6CEC0698-57BB-4483-A4FC-74B262D719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0910C15E-CCC8-4845-AC46-67B73B50FF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CCC09-8725-44F9-B521-A4E7DB0032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369214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D3D8BCEA-43BA-4914-93DA-B0A53C5812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2D03E-A0D0-407D-AEB6-117DCB17B8CB}" type="datetimeFigureOut">
              <a:rPr lang="ko-KR" altLang="en-US" smtClean="0"/>
              <a:t>2022-04-21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BE6A36DC-00A6-40C8-9BA2-E494E31B77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B4C51F85-E960-488F-96D9-BD52F38F29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CCC09-8725-44F9-B521-A4E7DB0032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23568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DB4C57E-7E13-425C-9352-73870D92CB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3A99FCB5-93DA-4984-8261-D274DF8C6DC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D0A5D9D5-7E18-40A9-B157-BE0CDCDE03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E16F2A5-AB06-492B-AD55-BF093366A1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2D03E-A0D0-407D-AEB6-117DCB17B8CB}" type="datetimeFigureOut">
              <a:rPr lang="ko-KR" altLang="en-US" smtClean="0"/>
              <a:t>2022-04-2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888EC2F9-7DC9-4A30-888C-904608476F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0C18DB0B-9C36-4157-9936-01D7C03F0E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CCC09-8725-44F9-B521-A4E7DB0032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76251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4D5D049-5C86-45BB-AC5C-887EB7CEB6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F836D993-71BC-46CC-BECD-5E18104D7BC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B2BBDB49-35FB-409C-9915-68CE8096ED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AE68A3B-1210-49CB-B432-DB9E700FDE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2D03E-A0D0-407D-AEB6-117DCB17B8CB}" type="datetimeFigureOut">
              <a:rPr lang="ko-KR" altLang="en-US" smtClean="0"/>
              <a:t>2022-04-2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8EDEB783-D767-4A01-ADF7-511699D075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C0932C1-F512-476B-AD66-5FCAAC561A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CCC09-8725-44F9-B521-A4E7DB0032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308914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02CFB41D-BD89-464B-86E9-77616B14D3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30BEDE8-928F-47AE-9420-85AB63950D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62BFFF7-50CB-4A60-A9DF-03C631A2DF5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52D03E-A0D0-407D-AEB6-117DCB17B8CB}" type="datetimeFigureOut">
              <a:rPr lang="ko-KR" altLang="en-US" smtClean="0"/>
              <a:t>2022-04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F3F414E-E208-4AA0-AD17-EF21D7BA12E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D799723-8968-4DFE-9E08-AF1A2ED541A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6CCC09-8725-44F9-B521-A4E7DB0032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400807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직사각형 6">
            <a:extLst>
              <a:ext uri="{FF2B5EF4-FFF2-40B4-BE49-F238E27FC236}">
                <a16:creationId xmlns:a16="http://schemas.microsoft.com/office/drawing/2014/main" id="{BE3AE559-35B7-4FF0-84E1-33F36C1826AC}"/>
              </a:ext>
            </a:extLst>
          </p:cNvPr>
          <p:cNvSpPr/>
          <p:nvPr/>
        </p:nvSpPr>
        <p:spPr>
          <a:xfrm>
            <a:off x="2836985" y="358727"/>
            <a:ext cx="1645920" cy="4761913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584ACFE-7281-40D9-9880-2F18CCE4932F}"/>
              </a:ext>
            </a:extLst>
          </p:cNvPr>
          <p:cNvSpPr txBox="1"/>
          <p:nvPr/>
        </p:nvSpPr>
        <p:spPr>
          <a:xfrm>
            <a:off x="3268393" y="358727"/>
            <a:ext cx="9003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Period 1</a:t>
            </a:r>
            <a:endParaRPr lang="ko-KR" altLang="en-US" sz="1400" b="1" dirty="0"/>
          </a:p>
        </p:txBody>
      </p:sp>
      <p:sp>
        <p:nvSpPr>
          <p:cNvPr id="9" name="직사각형 8">
            <a:extLst>
              <a:ext uri="{FF2B5EF4-FFF2-40B4-BE49-F238E27FC236}">
                <a16:creationId xmlns:a16="http://schemas.microsoft.com/office/drawing/2014/main" id="{6479F211-0386-4F78-B4FB-1800B459BCB6}"/>
              </a:ext>
            </a:extLst>
          </p:cNvPr>
          <p:cNvSpPr/>
          <p:nvPr/>
        </p:nvSpPr>
        <p:spPr>
          <a:xfrm>
            <a:off x="4485249" y="361072"/>
            <a:ext cx="1638886" cy="4761913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" name="직사각형 10">
            <a:extLst>
              <a:ext uri="{FF2B5EF4-FFF2-40B4-BE49-F238E27FC236}">
                <a16:creationId xmlns:a16="http://schemas.microsoft.com/office/drawing/2014/main" id="{BCE356C6-36EC-4E42-A083-672ED8008170}"/>
              </a:ext>
            </a:extLst>
          </p:cNvPr>
          <p:cNvSpPr/>
          <p:nvPr/>
        </p:nvSpPr>
        <p:spPr>
          <a:xfrm>
            <a:off x="6128824" y="358728"/>
            <a:ext cx="1631852" cy="4761913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" name="직사각형 12">
            <a:extLst>
              <a:ext uri="{FF2B5EF4-FFF2-40B4-BE49-F238E27FC236}">
                <a16:creationId xmlns:a16="http://schemas.microsoft.com/office/drawing/2014/main" id="{74F9CA64-F2AF-4424-B5C5-4D5000C20792}"/>
              </a:ext>
            </a:extLst>
          </p:cNvPr>
          <p:cNvSpPr/>
          <p:nvPr/>
        </p:nvSpPr>
        <p:spPr>
          <a:xfrm>
            <a:off x="7763021" y="361073"/>
            <a:ext cx="1643576" cy="4761913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" name="직사각형 14">
            <a:extLst>
              <a:ext uri="{FF2B5EF4-FFF2-40B4-BE49-F238E27FC236}">
                <a16:creationId xmlns:a16="http://schemas.microsoft.com/office/drawing/2014/main" id="{984EBC77-F739-4B5B-9AB9-B62D17C15AB8}"/>
              </a:ext>
            </a:extLst>
          </p:cNvPr>
          <p:cNvSpPr/>
          <p:nvPr/>
        </p:nvSpPr>
        <p:spPr>
          <a:xfrm>
            <a:off x="9411286" y="358729"/>
            <a:ext cx="1631852" cy="4761913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graphicFrame>
        <p:nvGraphicFramePr>
          <p:cNvPr id="5" name="차트 4">
            <a:extLst>
              <a:ext uri="{FF2B5EF4-FFF2-40B4-BE49-F238E27FC236}">
                <a16:creationId xmlns:a16="http://schemas.microsoft.com/office/drawing/2014/main" id="{49C81554-BEA2-4165-8311-8DA05EB1B2F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7985359"/>
              </p:ext>
            </p:extLst>
          </p:nvPr>
        </p:nvGraphicFramePr>
        <p:xfrm>
          <a:off x="1172308" y="772884"/>
          <a:ext cx="9966667" cy="57263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직사각형 5">
            <a:extLst>
              <a:ext uri="{FF2B5EF4-FFF2-40B4-BE49-F238E27FC236}">
                <a16:creationId xmlns:a16="http://schemas.microsoft.com/office/drawing/2014/main" id="{375D4052-4D2A-4026-8E4A-A8B54C4653CC}"/>
              </a:ext>
            </a:extLst>
          </p:cNvPr>
          <p:cNvSpPr/>
          <p:nvPr/>
        </p:nvSpPr>
        <p:spPr>
          <a:xfrm>
            <a:off x="2754631" y="5209735"/>
            <a:ext cx="8377603" cy="11254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B10F5EA-0502-4A03-A584-4B27A1C8C60D}"/>
              </a:ext>
            </a:extLst>
          </p:cNvPr>
          <p:cNvSpPr txBox="1"/>
          <p:nvPr/>
        </p:nvSpPr>
        <p:spPr>
          <a:xfrm>
            <a:off x="9384322" y="356385"/>
            <a:ext cx="16857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/>
              <a:t>Period 5</a:t>
            </a:r>
          </a:p>
          <a:p>
            <a:pPr algn="ctr"/>
            <a:r>
              <a:rPr lang="en-US" altLang="ko-KR" sz="900" b="1" dirty="0"/>
              <a:t>omicron variant dominant</a:t>
            </a:r>
            <a:endParaRPr lang="ko-KR" altLang="en-US" sz="1200" b="1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5DBBAFA-F742-4D90-BAFB-4438FA467AF7}"/>
              </a:ext>
            </a:extLst>
          </p:cNvPr>
          <p:cNvSpPr txBox="1"/>
          <p:nvPr/>
        </p:nvSpPr>
        <p:spPr>
          <a:xfrm>
            <a:off x="7741919" y="368110"/>
            <a:ext cx="16857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/>
              <a:t>Period 4</a:t>
            </a:r>
          </a:p>
          <a:p>
            <a:pPr algn="ctr"/>
            <a:r>
              <a:rPr lang="en-US" altLang="ko-KR" sz="900" b="1" dirty="0"/>
              <a:t>delta variant dominant</a:t>
            </a:r>
            <a:endParaRPr lang="ko-KR" altLang="en-US" sz="1200" b="1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218FF5F-9333-4F26-B95D-4100BE4995F8}"/>
              </a:ext>
            </a:extLst>
          </p:cNvPr>
          <p:cNvSpPr txBox="1"/>
          <p:nvPr/>
        </p:nvSpPr>
        <p:spPr>
          <a:xfrm>
            <a:off x="6100542" y="365765"/>
            <a:ext cx="16857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/>
              <a:t>Period 3</a:t>
            </a:r>
          </a:p>
          <a:p>
            <a:pPr algn="ctr"/>
            <a:r>
              <a:rPr lang="en-US" altLang="ko-KR" sz="900" b="1" dirty="0"/>
              <a:t>delta variant dominant</a:t>
            </a:r>
            <a:endParaRPr lang="ko-KR" altLang="en-US" sz="1200" b="1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F33E16E-4086-4640-97F7-6E5F9E4941C2}"/>
              </a:ext>
            </a:extLst>
          </p:cNvPr>
          <p:cNvSpPr txBox="1"/>
          <p:nvPr/>
        </p:nvSpPr>
        <p:spPr>
          <a:xfrm>
            <a:off x="4456966" y="363420"/>
            <a:ext cx="16857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/>
              <a:t>Period 2</a:t>
            </a:r>
          </a:p>
          <a:p>
            <a:pPr algn="ctr"/>
            <a:r>
              <a:rPr lang="en-US" altLang="ko-KR" sz="900" b="1" dirty="0"/>
              <a:t>alpha variant dominant</a:t>
            </a:r>
            <a:endParaRPr lang="ko-KR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7334370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</TotalTime>
  <Words>22</Words>
  <Application>Microsoft Office PowerPoint</Application>
  <PresentationFormat>와이드스크린</PresentationFormat>
  <Paragraphs>9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도균</dc:creator>
  <cp:lastModifiedBy>김도균</cp:lastModifiedBy>
  <cp:revision>2</cp:revision>
  <dcterms:created xsi:type="dcterms:W3CDTF">2022-04-20T23:38:10Z</dcterms:created>
  <dcterms:modified xsi:type="dcterms:W3CDTF">2022-04-21T06:12:31Z</dcterms:modified>
</cp:coreProperties>
</file>